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  <p:sldId id="259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3"/>
    <p:restoredTop sz="94693"/>
  </p:normalViewPr>
  <p:slideViewPr>
    <p:cSldViewPr snapToGrid="0" snapToObjects="1">
      <p:cViewPr varScale="1">
        <p:scale>
          <a:sx n="78" d="100"/>
          <a:sy n="78" d="100"/>
        </p:scale>
        <p:origin x="2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292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58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805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1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32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7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520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680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948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854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589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69CE7-0D12-584D-8172-05E916102760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78DCC-1F6D-1144-B149-D173BCBDCF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679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1413" y="420601"/>
            <a:ext cx="6261903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2A associated with Figure 4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Nkx2.2 bound and regulated genes that are also Rfx6 bound (120 genes) or NeuroD1 bound (92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1 of 3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:\Users\Angela\Documents\NYC\Sussel Lab\EPKO\EPKO Paper Figures\Supp Table 4_Page_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2" t="7597" r="59848" b="9069"/>
          <a:stretch/>
        </p:blipFill>
        <p:spPr bwMode="auto">
          <a:xfrm>
            <a:off x="1362919" y="1485417"/>
            <a:ext cx="3467100" cy="6477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Angela\Documents\NYC\Sussel Lab\EPKO\EPKO Paper Figures\Supp Table 4_Page_2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1" t="8295" r="59660" b="7842"/>
          <a:stretch/>
        </p:blipFill>
        <p:spPr bwMode="auto">
          <a:xfrm>
            <a:off x="6942641" y="1814730"/>
            <a:ext cx="3486150" cy="6518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02261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51390" y="420601"/>
            <a:ext cx="5047526" cy="10926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File 2A associated with Figure 4.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 bound and regulated genes that are also Rfx6 bound (120 genes) or NeuroD1 bound (92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2 of 3</a:t>
            </a:r>
          </a:p>
        </p:txBody>
      </p:sp>
      <p:pic>
        <p:nvPicPr>
          <p:cNvPr id="4" name="Picture 3" descr="C:\Users\Angela\Documents\NYC\Sussel Lab\EPKO\EPKO Paper Figures\Supp Table 4_Page_2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81" t="8295" r="59660" b="7842"/>
          <a:stretch/>
        </p:blipFill>
        <p:spPr bwMode="auto">
          <a:xfrm>
            <a:off x="1532078" y="1710558"/>
            <a:ext cx="3486150" cy="6518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121670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51390" y="420601"/>
            <a:ext cx="5047526" cy="10926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File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2A associated with Figure 4.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kx2.2 bound and regulated genes that are also Rfx6 bound (120 genes) or NeuroD1 bound (92 gene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age 3 of 3</a:t>
            </a:r>
          </a:p>
        </p:txBody>
      </p:sp>
      <p:pic>
        <p:nvPicPr>
          <p:cNvPr id="5" name="Picture 2" descr="C:\Users\Angela\Documents\NYC\Sussel Lab\EPKO\EPKO Paper Figures\Supp Table 4_Page_3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2" t="7598" r="59848" b="7843"/>
          <a:stretch/>
        </p:blipFill>
        <p:spPr bwMode="auto">
          <a:xfrm>
            <a:off x="1414523" y="1589721"/>
            <a:ext cx="3448050" cy="6572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70298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9</Words>
  <Application>Microsoft Macintosh PowerPoint</Application>
  <PresentationFormat>Letter Paper (8.5x11 in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Calibri</vt:lpstr>
      <vt:lpstr>Calibri Light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16-08-03T22:47:30Z</dcterms:created>
  <dcterms:modified xsi:type="dcterms:W3CDTF">2016-08-04T16:57:25Z</dcterms:modified>
</cp:coreProperties>
</file>